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63" r:id="rId3"/>
    <p:sldId id="26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47489"/>
    <a:srgbClr val="00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mtiyaz Hassan" userId="cecd73ea0150418c" providerId="LiveId" clId="{D0AAB0B9-7B27-4D4A-BD43-10F326E1C59E}"/>
    <pc:docChg chg="modSld">
      <pc:chgData name="Imtiyaz Hassan" userId="cecd73ea0150418c" providerId="LiveId" clId="{D0AAB0B9-7B27-4D4A-BD43-10F326E1C59E}" dt="2025-04-14T11:06:28.677" v="3" actId="14100"/>
      <pc:docMkLst>
        <pc:docMk/>
      </pc:docMkLst>
      <pc:sldChg chg="modSp mod">
        <pc:chgData name="Imtiyaz Hassan" userId="cecd73ea0150418c" providerId="LiveId" clId="{D0AAB0B9-7B27-4D4A-BD43-10F326E1C59E}" dt="2025-04-14T11:06:28.677" v="3" actId="14100"/>
        <pc:sldMkLst>
          <pc:docMk/>
          <pc:sldMk cId="2018240360" sldId="263"/>
        </pc:sldMkLst>
        <pc:picChg chg="mod">
          <ac:chgData name="Imtiyaz Hassan" userId="cecd73ea0150418c" providerId="LiveId" clId="{D0AAB0B9-7B27-4D4A-BD43-10F326E1C59E}" dt="2025-04-14T11:06:28.677" v="3" actId="14100"/>
          <ac:picMkLst>
            <pc:docMk/>
            <pc:sldMk cId="2018240360" sldId="263"/>
            <ac:picMk id="4" creationId="{FA4B1444-D1D9-21D4-2EA2-EB9B0ECC958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DA8388-112A-4BF1-8E3E-87E869DD9E19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94A8CA-9C80-4593-B7AF-CCC5E09B941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873036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B245C0-4FC0-59A7-4747-F3A5DE44BD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5ED4C8-D11E-E244-9808-E63D951035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A43424-133C-49F7-E1A2-B66ABB8ED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EFBB77-7C38-25A9-6EF2-51F4358CB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AB76CB-4BED-79EC-5818-ED7EECA5A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0484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84E1D-E093-F54A-42D8-FD0401F234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0B0621-3356-E0CC-5E42-013D70B9A4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CC4474-18E0-0DE8-6F55-9C7367184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D0743C-668E-B5FF-6754-10ABB1477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E712B7-BB18-D646-C3E4-7E5688B7E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0347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EA9225-41D1-A0B5-59E8-B70B356458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C93D0A-586D-4BD7-DD82-8FFD82AACB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4276A7-F156-7A1F-88AA-19BD22AC6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5295C1-9E24-7852-7C2D-8A8BB6D70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349273-81D0-0EC4-4B34-FEEFD8CF6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5468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CCD97-54ED-2EE6-41D5-BF6BA3050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3A24A5-4035-2D8F-D28C-54E9D318A4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02D8D7-711B-F512-D1F3-C867A78E8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8134AE-1550-16A0-FE78-CE17D1B92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BAAD4E-4BEB-D208-DA89-B58656606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0776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3DD577-10E0-E20F-58E3-D165506BB9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96EBA5-A1D5-4970-B97E-51E23B50D7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C1B4C2-A2C4-9EAC-A485-2D8DB9AEF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E62E0-4DCD-CFED-2C77-386A027F4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FF9158-4E5F-7184-74AD-4BAE99F75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2957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59A4E9-7FDE-FCB5-4266-572B27F86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C97D4C-B9AB-7167-72E1-575F0AA262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F3953A-F407-A03A-DCAC-F6EDE20E3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73BB2B-D577-C667-A797-CEE704B7F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81A2C7-AB09-CB71-4921-7D70FAFC0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01F3BD-DA0E-B9E9-382E-86B6E255D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53640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576FC0-2994-9356-74E0-0BA673220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B488BF-0A3D-D0AE-288D-E88B2C99E1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AB0B31-494F-E2AC-C187-971FEC5C1B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4E0F1B-2878-2B92-B36D-040595F6A3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315992-A9D0-8D6E-7911-EB471502B6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8672671-D437-83AC-09B6-3FEFBC74D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3CDBE5-78A9-F9AC-FFF5-CF86AD385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AF0308-7627-F7AB-CFAA-2636424DD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3528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7A186E-C3E6-FF77-7ADC-BC35619236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FC656B-138D-CF25-F547-198562FED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B941AD-A8D5-0561-9512-B2B1556C5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E529A22-E8A7-EF7A-ED9E-45728ABDB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4354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AE82CD0-8B8E-EB5A-4B85-42EF59601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7CD444-7A7E-CFD2-DD49-465641875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433D6C-C9C9-0B2F-CFD0-FC804F560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6581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E6FD8D-03E3-4A53-2394-3988ADC636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614B79-DE4B-F8C1-3E12-70E9B54B36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22E600-77F6-5D8D-FD91-1284D6EF4C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C21386-4CD3-D2DC-CF5F-95A595BE8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DC38C1-99F1-EACB-163E-6C186EA7E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5B3B61-2D8F-3FE7-4D82-26D16C516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0123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6786B5-720C-4EA1-3FC7-C8CC97F5F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9068B81-BB45-DA04-39DE-65844B76AF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9F235F-F608-7178-F65F-CE0E4168BA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82B937-9D6A-DAF5-D107-B623B3139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395681-6F48-D7A8-E3E5-B96097EBF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6D8CAE-50E4-C3B8-4EE6-5BB6D455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7485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2392B4-9930-1E97-6DA4-C61F64E73C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06D56E-05CD-76FC-5B85-8A033412FA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CE463C-B00F-C373-C969-A3EE586CE0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A50456-8D04-4586-B68D-4D21B75477CD}" type="datetimeFigureOut">
              <a:rPr lang="en-IN" smtClean="0"/>
              <a:t>22-04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F3CB05-180F-5544-DEC3-583D2849A6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25A72E-5691-E5C5-D4F3-9264788F20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5401DE-7067-4384-AEA1-C7196EDA3E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50460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0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B085099-CEE0-E693-389A-41005238687E}"/>
              </a:ext>
            </a:extLst>
          </p:cNvPr>
          <p:cNvSpPr txBox="1"/>
          <p:nvPr/>
        </p:nvSpPr>
        <p:spPr>
          <a:xfrm>
            <a:off x="188536" y="6230148"/>
            <a:ext cx="120034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074738" indent="-1074738" algn="just"/>
            <a:r>
              <a:rPr lang="en-IN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igure S1: </a:t>
            </a:r>
            <a:r>
              <a:rPr lang="en-IN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ERT in complex with co-crystalized (yellow) and docked (cyan) Paroxetine. </a:t>
            </a:r>
            <a:r>
              <a:rPr lang="en-US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The RMSD between co-crystallized and redocked Paroxetine is 1.286 Å. </a:t>
            </a:r>
            <a:r>
              <a:rPr lang="en-IN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The figure was drawn in PyMOL using the PDB coordinates with ID: </a:t>
            </a:r>
            <a:r>
              <a:rPr lang="en-IN" b="0" i="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5I6X. </a:t>
            </a:r>
          </a:p>
        </p:txBody>
      </p:sp>
      <p:pic>
        <p:nvPicPr>
          <p:cNvPr id="11" name="Picture 10" descr="A close-up of a spiral&#10;&#10;AI-generated content may be incorrect.">
            <a:extLst>
              <a:ext uri="{FF2B5EF4-FFF2-40B4-BE49-F238E27FC236}">
                <a16:creationId xmlns:a16="http://schemas.microsoft.com/office/drawing/2014/main" id="{4A0019B4-ED70-0627-FF79-D11CBF8116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70" t="2668" r="33273" b="406"/>
          <a:stretch/>
        </p:blipFill>
        <p:spPr>
          <a:xfrm>
            <a:off x="188536" y="0"/>
            <a:ext cx="3932788" cy="621118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2A3562D-F7C3-5536-522B-2CC86091141E}"/>
              </a:ext>
            </a:extLst>
          </p:cNvPr>
          <p:cNvSpPr txBox="1"/>
          <p:nvPr/>
        </p:nvSpPr>
        <p:spPr>
          <a:xfrm>
            <a:off x="1637693" y="5304090"/>
            <a:ext cx="2522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solidFill>
                  <a:srgbClr val="74748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RT (PDB ID: 5I6X)</a:t>
            </a:r>
          </a:p>
        </p:txBody>
      </p:sp>
      <p:pic>
        <p:nvPicPr>
          <p:cNvPr id="4" name="Picture 3" descr="A colorful molecule structure on a black background&#10;&#10;AI-generated content may be incorrect.">
            <a:extLst>
              <a:ext uri="{FF2B5EF4-FFF2-40B4-BE49-F238E27FC236}">
                <a16:creationId xmlns:a16="http://schemas.microsoft.com/office/drawing/2014/main" id="{5A41A671-B764-DEF4-5780-0FB773DD1A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73" t="10707" r="28790" b="5742"/>
          <a:stretch/>
        </p:blipFill>
        <p:spPr>
          <a:xfrm>
            <a:off x="7616001" y="1066200"/>
            <a:ext cx="4575999" cy="3622384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45382D1-2B7B-08F3-95F2-415652A5352A}"/>
              </a:ext>
            </a:extLst>
          </p:cNvPr>
          <p:cNvCxnSpPr>
            <a:cxnSpLocks/>
          </p:cNvCxnSpPr>
          <p:nvPr/>
        </p:nvCxnSpPr>
        <p:spPr>
          <a:xfrm>
            <a:off x="7022221" y="894735"/>
            <a:ext cx="1561340" cy="12192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E89F68E-1FD2-8E6C-A9E1-6AC0AD901811}"/>
              </a:ext>
            </a:extLst>
          </p:cNvPr>
          <p:cNvSpPr txBox="1"/>
          <p:nvPr/>
        </p:nvSpPr>
        <p:spPr>
          <a:xfrm>
            <a:off x="4564627" y="677802"/>
            <a:ext cx="2576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-crystalized Paroxetine</a:t>
            </a:r>
            <a:endParaRPr lang="en-IN" sz="1600" b="0" i="0" dirty="0">
              <a:solidFill>
                <a:srgbClr val="FFC000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8E7DD55-8B56-4621-439F-E630A34DDDD0}"/>
              </a:ext>
            </a:extLst>
          </p:cNvPr>
          <p:cNvSpPr txBox="1"/>
          <p:nvPr/>
        </p:nvSpPr>
        <p:spPr>
          <a:xfrm>
            <a:off x="4583481" y="1015620"/>
            <a:ext cx="1976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ed Paroxetine</a:t>
            </a:r>
            <a:endParaRPr lang="en-IN" sz="1600" b="0" i="0" dirty="0">
              <a:solidFill>
                <a:srgbClr val="00B0F0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2705618-829E-298D-6067-EB1F153DF21A}"/>
              </a:ext>
            </a:extLst>
          </p:cNvPr>
          <p:cNvCxnSpPr>
            <a:cxnSpLocks/>
            <a:stCxn id="13" idx="3"/>
          </p:cNvCxnSpPr>
          <p:nvPr/>
        </p:nvCxnSpPr>
        <p:spPr>
          <a:xfrm>
            <a:off x="6560064" y="1184897"/>
            <a:ext cx="2898568" cy="15189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830DB787-A34A-76C5-D78B-3B96928868BA}"/>
              </a:ext>
            </a:extLst>
          </p:cNvPr>
          <p:cNvCxnSpPr>
            <a:cxnSpLocks/>
          </p:cNvCxnSpPr>
          <p:nvPr/>
        </p:nvCxnSpPr>
        <p:spPr>
          <a:xfrm flipH="1">
            <a:off x="2036619" y="894735"/>
            <a:ext cx="2618971" cy="21189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1EFDD3D5-F95B-DB14-F809-AD3BEAAC1B58}"/>
              </a:ext>
            </a:extLst>
          </p:cNvPr>
          <p:cNvCxnSpPr>
            <a:cxnSpLocks/>
          </p:cNvCxnSpPr>
          <p:nvPr/>
        </p:nvCxnSpPr>
        <p:spPr>
          <a:xfrm flipH="1">
            <a:off x="2340077" y="1233289"/>
            <a:ext cx="2306180" cy="18990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046CF649-4647-3145-3118-24D9EB450D7F}"/>
              </a:ext>
            </a:extLst>
          </p:cNvPr>
          <p:cNvSpPr txBox="1"/>
          <p:nvPr/>
        </p:nvSpPr>
        <p:spPr>
          <a:xfrm>
            <a:off x="4756543" y="3170207"/>
            <a:ext cx="22242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074738" indent="-1074738" algn="ctr"/>
            <a:r>
              <a:rPr lang="en-IN" sz="24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MSD 1.286 Å</a:t>
            </a:r>
            <a:endParaRPr lang="en-IN" sz="2400" b="0" i="0" dirty="0">
              <a:solidFill>
                <a:srgbClr val="333333"/>
              </a:solidFill>
              <a:effectLst/>
              <a:highlight>
                <a:srgbClr val="FFFFFF"/>
              </a:highlight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643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F45FF6B-EBD2-3A9F-5BFD-952A121C7F49}"/>
              </a:ext>
            </a:extLst>
          </p:cNvPr>
          <p:cNvSpPr txBox="1"/>
          <p:nvPr/>
        </p:nvSpPr>
        <p:spPr>
          <a:xfrm>
            <a:off x="42269" y="6394401"/>
            <a:ext cx="12107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074738" indent="-1074738" algn="ctr"/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Intramolecular hydrogen bonding in SERT at 200-300 ns. </a:t>
            </a:r>
            <a:endParaRPr lang="en-IN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of a blue and red graph&#10;&#10;AI-generated content may be incorrect.">
            <a:extLst>
              <a:ext uri="{FF2B5EF4-FFF2-40B4-BE49-F238E27FC236}">
                <a16:creationId xmlns:a16="http://schemas.microsoft.com/office/drawing/2014/main" id="{FA4B1444-D1D9-21D4-2EA2-EB9B0ECC95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2" t="4678" r="39818" b="8290"/>
          <a:stretch/>
        </p:blipFill>
        <p:spPr>
          <a:xfrm>
            <a:off x="2316957" y="160257"/>
            <a:ext cx="7558086" cy="623414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414A5E6-E866-4E98-97AF-B83C93985AEC}"/>
              </a:ext>
            </a:extLst>
          </p:cNvPr>
          <p:cNvSpPr txBox="1"/>
          <p:nvPr/>
        </p:nvSpPr>
        <p:spPr>
          <a:xfrm>
            <a:off x="6571022" y="980511"/>
            <a:ext cx="173646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ERT</a:t>
            </a:r>
          </a:p>
          <a:p>
            <a:r>
              <a: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T-Flunarizine</a:t>
            </a:r>
          </a:p>
          <a:p>
            <a:r>
              <a:rPr lang="en-US" sz="14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T-Paroxetine</a:t>
            </a:r>
          </a:p>
        </p:txBody>
      </p:sp>
    </p:spTree>
    <p:extLst>
      <p:ext uri="{BB962C8B-B14F-4D97-AF65-F5344CB8AC3E}">
        <p14:creationId xmlns:p14="http://schemas.microsoft.com/office/powerpoint/2010/main" val="2018240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C7B32B-A316-8E7D-863E-870FA0F702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>
            <a:extLst>
              <a:ext uri="{FF2B5EF4-FFF2-40B4-BE49-F238E27FC236}">
                <a16:creationId xmlns:a16="http://schemas.microsoft.com/office/drawing/2014/main" id="{7D951B7F-3A02-3199-7863-1AFC324A1548}"/>
              </a:ext>
            </a:extLst>
          </p:cNvPr>
          <p:cNvGrpSpPr/>
          <p:nvPr/>
        </p:nvGrpSpPr>
        <p:grpSpPr>
          <a:xfrm>
            <a:off x="62715" y="70380"/>
            <a:ext cx="10973326" cy="5881213"/>
            <a:chOff x="62715" y="70380"/>
            <a:chExt cx="10973326" cy="5881213"/>
          </a:xfrm>
        </p:grpSpPr>
        <p:pic>
          <p:nvPicPr>
            <p:cNvPr id="3" name="Picture 2" descr="A graph of different colored lines&#10;&#10;Description automatically generated">
              <a:extLst>
                <a:ext uri="{FF2B5EF4-FFF2-40B4-BE49-F238E27FC236}">
                  <a16:creationId xmlns:a16="http://schemas.microsoft.com/office/drawing/2014/main" id="{F8AA2B47-2B25-1409-296B-3D55BCCC77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6" t="13082" r="17718" b="28607"/>
            <a:stretch/>
          </p:blipFill>
          <p:spPr>
            <a:xfrm>
              <a:off x="331895" y="239658"/>
              <a:ext cx="5126225" cy="2846442"/>
            </a:xfrm>
            <a:prstGeom prst="rect">
              <a:avLst/>
            </a:prstGeom>
          </p:spPr>
        </p:pic>
        <p:pic>
          <p:nvPicPr>
            <p:cNvPr id="5" name="Picture 4" descr="A graph showing different colored lines&#10;&#10;Description automatically generated">
              <a:extLst>
                <a:ext uri="{FF2B5EF4-FFF2-40B4-BE49-F238E27FC236}">
                  <a16:creationId xmlns:a16="http://schemas.microsoft.com/office/drawing/2014/main" id="{A57DC464-2CBE-7D48-DEB3-B96F0E51EC5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7" t="12827" r="16645" b="29038"/>
            <a:stretch/>
          </p:blipFill>
          <p:spPr>
            <a:xfrm>
              <a:off x="331894" y="3086101"/>
              <a:ext cx="5244545" cy="2865492"/>
            </a:xfrm>
            <a:prstGeom prst="rect">
              <a:avLst/>
            </a:prstGeom>
          </p:spPr>
        </p:pic>
        <p:pic>
          <p:nvPicPr>
            <p:cNvPr id="7" name="Picture 6" descr="A graph showing different colored lines&#10;&#10;Description automatically generated">
              <a:extLst>
                <a:ext uri="{FF2B5EF4-FFF2-40B4-BE49-F238E27FC236}">
                  <a16:creationId xmlns:a16="http://schemas.microsoft.com/office/drawing/2014/main" id="{C29514BE-4A23-0EE9-069A-9F92382696C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7" t="13164" r="16513" b="28995"/>
            <a:stretch/>
          </p:blipFill>
          <p:spPr>
            <a:xfrm>
              <a:off x="5791495" y="239658"/>
              <a:ext cx="5244546" cy="2846442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8FE5E40E-44D1-8128-900F-4D270E0FC709}"/>
                </a:ext>
              </a:extLst>
            </p:cNvPr>
            <p:cNvSpPr/>
            <p:nvPr/>
          </p:nvSpPr>
          <p:spPr>
            <a:xfrm>
              <a:off x="5173951" y="923827"/>
              <a:ext cx="391697" cy="16025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FFFA7FE2-4772-70A2-F10E-D50DF042A60B}"/>
                </a:ext>
              </a:extLst>
            </p:cNvPr>
            <p:cNvGrpSpPr/>
            <p:nvPr/>
          </p:nvGrpSpPr>
          <p:grpSpPr>
            <a:xfrm>
              <a:off x="6435992" y="3429000"/>
              <a:ext cx="1428452" cy="2430113"/>
              <a:chOff x="9800098" y="1957227"/>
              <a:chExt cx="1428452" cy="2430113"/>
            </a:xfrm>
          </p:grpSpPr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63A27DE-FAFC-732A-75D0-D8D241868E8C}"/>
                  </a:ext>
                </a:extLst>
              </p:cNvPr>
              <p:cNvSpPr txBox="1"/>
              <p:nvPr/>
            </p:nvSpPr>
            <p:spPr>
              <a:xfrm>
                <a:off x="10314150" y="1982474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ructure</a:t>
                </a: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F990A4B3-4F33-CA7A-8BB8-6CE580EFB038}"/>
                  </a:ext>
                </a:extLst>
              </p:cNvPr>
              <p:cNvSpPr/>
              <p:nvPr/>
            </p:nvSpPr>
            <p:spPr>
              <a:xfrm>
                <a:off x="9800098" y="1957227"/>
                <a:ext cx="1274618" cy="243011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FD8FA089-F266-E59D-AF81-4933319C69A5}"/>
                  </a:ext>
                </a:extLst>
              </p:cNvPr>
              <p:cNvSpPr/>
              <p:nvPr/>
            </p:nvSpPr>
            <p:spPr>
              <a:xfrm flipV="1">
                <a:off x="9922572" y="2789275"/>
                <a:ext cx="374904" cy="45719"/>
              </a:xfrm>
              <a:prstGeom prst="rect">
                <a:avLst/>
              </a:prstGeom>
              <a:solidFill>
                <a:srgbClr val="0B0EFF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/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008340D3-E13C-2FDD-E1EA-AA6B8BFCC269}"/>
                  </a:ext>
                </a:extLst>
              </p:cNvPr>
              <p:cNvSpPr/>
              <p:nvPr/>
            </p:nvSpPr>
            <p:spPr>
              <a:xfrm flipV="1">
                <a:off x="9922572" y="2996539"/>
                <a:ext cx="374904" cy="45719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12D81A8-0753-8FC6-54A8-4DBB4F2ECE19}"/>
                  </a:ext>
                </a:extLst>
              </p:cNvPr>
              <p:cNvSpPr txBox="1"/>
              <p:nvPr/>
            </p:nvSpPr>
            <p:spPr>
              <a:xfrm>
                <a:off x="10297476" y="2682168"/>
                <a:ext cx="8436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-Bridg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EB1ADA2-371F-E03E-1794-C61E912CA4DF}"/>
                  </a:ext>
                </a:extLst>
              </p:cNvPr>
              <p:cNvSpPr txBox="1"/>
              <p:nvPr/>
            </p:nvSpPr>
            <p:spPr>
              <a:xfrm>
                <a:off x="10297476" y="2902442"/>
                <a:ext cx="84369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end</a:t>
                </a:r>
              </a:p>
              <a:p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5A3E0D45-BB1A-4F9A-69D4-BAE2864EE464}"/>
                  </a:ext>
                </a:extLst>
              </p:cNvPr>
              <p:cNvSpPr/>
              <p:nvPr/>
            </p:nvSpPr>
            <p:spPr>
              <a:xfrm flipV="1">
                <a:off x="9922572" y="3256967"/>
                <a:ext cx="374904" cy="45719"/>
              </a:xfrm>
              <a:prstGeom prst="rect">
                <a:avLst/>
              </a:prstGeom>
              <a:solidFill>
                <a:srgbClr val="993366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>
                  <a:solidFill>
                    <a:srgbClr val="00FF00"/>
                  </a:solidFill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D65AD5A-2ECC-6CC8-1AB7-11D1975CBEA4}"/>
                  </a:ext>
                </a:extLst>
              </p:cNvPr>
              <p:cNvSpPr txBox="1"/>
              <p:nvPr/>
            </p:nvSpPr>
            <p:spPr>
              <a:xfrm>
                <a:off x="10297476" y="3132991"/>
                <a:ext cx="8436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rn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3DAB5415-F5DD-DD3C-29A4-6A16D18F4F30}"/>
                  </a:ext>
                </a:extLst>
              </p:cNvPr>
              <p:cNvSpPr/>
              <p:nvPr/>
            </p:nvSpPr>
            <p:spPr>
              <a:xfrm flipV="1">
                <a:off x="9922572" y="2105177"/>
                <a:ext cx="374904" cy="45719"/>
              </a:xfrm>
              <a:prstGeom prst="rect">
                <a:avLst/>
              </a:prstGeom>
              <a:solidFill>
                <a:srgbClr val="000000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779670A4-EEE7-14F1-55F4-8CAAC68A2DCD}"/>
                  </a:ext>
                </a:extLst>
              </p:cNvPr>
              <p:cNvSpPr/>
              <p:nvPr/>
            </p:nvSpPr>
            <p:spPr>
              <a:xfrm flipV="1">
                <a:off x="9922572" y="2312441"/>
                <a:ext cx="374904" cy="45719"/>
              </a:xfrm>
              <a:prstGeom prst="rect">
                <a:avLst/>
              </a:prstGeom>
              <a:solidFill>
                <a:srgbClr val="FF1C1C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088B113D-77BF-87BE-BACD-F03F049A78D8}"/>
                  </a:ext>
                </a:extLst>
              </p:cNvPr>
              <p:cNvSpPr txBox="1"/>
              <p:nvPr/>
            </p:nvSpPr>
            <p:spPr>
              <a:xfrm>
                <a:off x="10297476" y="2192252"/>
                <a:ext cx="84369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il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445E498B-E5E7-34A4-1ED3-BB1E2C120F15}"/>
                  </a:ext>
                </a:extLst>
              </p:cNvPr>
              <p:cNvSpPr/>
              <p:nvPr/>
            </p:nvSpPr>
            <p:spPr>
              <a:xfrm flipV="1">
                <a:off x="9922572" y="2572869"/>
                <a:ext cx="374904" cy="45719"/>
              </a:xfrm>
              <a:prstGeom prst="rect">
                <a:avLst/>
              </a:prstGeom>
              <a:solidFill>
                <a:srgbClr val="00FF00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>
                  <a:solidFill>
                    <a:srgbClr val="00FF00"/>
                  </a:solidFill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5FB44158-FF45-2346-70C3-28FFCF4F1355}"/>
                  </a:ext>
                </a:extLst>
              </p:cNvPr>
              <p:cNvSpPr txBox="1"/>
              <p:nvPr/>
            </p:nvSpPr>
            <p:spPr>
              <a:xfrm>
                <a:off x="10297476" y="2451777"/>
                <a:ext cx="8436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-Sheet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03EEB827-8733-83CB-0815-3C347C023381}"/>
                  </a:ext>
                </a:extLst>
              </p:cNvPr>
              <p:cNvSpPr/>
              <p:nvPr/>
            </p:nvSpPr>
            <p:spPr>
              <a:xfrm flipV="1">
                <a:off x="9922572" y="3504345"/>
                <a:ext cx="374904" cy="45719"/>
              </a:xfrm>
              <a:prstGeom prst="rect">
                <a:avLst/>
              </a:prstGeom>
              <a:solidFill>
                <a:srgbClr val="BC8F8F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B0505E5C-6D2B-D9EC-AD15-352DAFC24902}"/>
                  </a:ext>
                </a:extLst>
              </p:cNvPr>
              <p:cNvSpPr/>
              <p:nvPr/>
            </p:nvSpPr>
            <p:spPr>
              <a:xfrm flipV="1">
                <a:off x="9922572" y="3748454"/>
                <a:ext cx="374904" cy="45719"/>
              </a:xfrm>
              <a:prstGeom prst="rect">
                <a:avLst/>
              </a:prstGeom>
              <a:solidFill>
                <a:srgbClr val="7030A0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06F9EAF5-1629-5670-9107-892EF7362CDB}"/>
                  </a:ext>
                </a:extLst>
              </p:cNvPr>
              <p:cNvSpPr txBox="1"/>
              <p:nvPr/>
            </p:nvSpPr>
            <p:spPr>
              <a:xfrm>
                <a:off x="10297476" y="3361998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-Helix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5D54FFF1-E1A6-534A-7D6F-CB726321C253}"/>
                  </a:ext>
                </a:extLst>
              </p:cNvPr>
              <p:cNvSpPr txBox="1"/>
              <p:nvPr/>
            </p:nvSpPr>
            <p:spPr>
              <a:xfrm>
                <a:off x="10297476" y="3627456"/>
                <a:ext cx="7605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-Helix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EEB5AC64-65D3-48D9-8750-7578D5357B4E}"/>
                  </a:ext>
                </a:extLst>
              </p:cNvPr>
              <p:cNvSpPr/>
              <p:nvPr/>
            </p:nvSpPr>
            <p:spPr>
              <a:xfrm flipV="1">
                <a:off x="9922572" y="3972037"/>
                <a:ext cx="374904" cy="45719"/>
              </a:xfrm>
              <a:prstGeom prst="rect">
                <a:avLst/>
              </a:prstGeom>
              <a:solidFill>
                <a:srgbClr val="00FFFF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>
                  <a:solidFill>
                    <a:srgbClr val="00FF00"/>
                  </a:solidFill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C3051BE-7E31-E2CB-6141-8266D05CAA45}"/>
                  </a:ext>
                </a:extLst>
              </p:cNvPr>
              <p:cNvSpPr txBox="1"/>
              <p:nvPr/>
            </p:nvSpPr>
            <p:spPr>
              <a:xfrm>
                <a:off x="10297476" y="3875480"/>
                <a:ext cx="7605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IN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Helix</a:t>
                </a:r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B19C1765-1A0C-C711-6605-3529C0FD3072}"/>
                  </a:ext>
                </a:extLst>
              </p:cNvPr>
              <p:cNvSpPr/>
              <p:nvPr/>
            </p:nvSpPr>
            <p:spPr>
              <a:xfrm flipV="1">
                <a:off x="9922572" y="4209776"/>
                <a:ext cx="374904" cy="45719"/>
              </a:xfrm>
              <a:prstGeom prst="rect">
                <a:avLst/>
              </a:prstGeom>
              <a:solidFill>
                <a:srgbClr val="FF00FF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200">
                  <a:solidFill>
                    <a:srgbClr val="00FF00"/>
                  </a:solidFill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1CAB69A0-8C9E-6272-A8BD-16F59003C143}"/>
                      </a:ext>
                    </a:extLst>
                  </p:cNvPr>
                  <p:cNvSpPr txBox="1"/>
                  <p:nvPr/>
                </p:nvSpPr>
                <p:spPr>
                  <a:xfrm>
                    <a:off x="10314150" y="4110341"/>
                    <a:ext cx="76056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14:m>
                      <m:oMath xmlns:m="http://schemas.openxmlformats.org/officeDocument/2006/math">
                        <m:r>
                          <m:rPr>
                            <m:sty m:val="p"/>
                          </m:rPr>
                          <a:rPr lang="en-IN" sz="1200" b="0" i="1" smtClean="0"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κ</m:t>
                        </m:r>
                      </m:oMath>
                    </a14:m>
                    <a:r>
                      <a:rPr lang="en-IN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Helix</a:t>
                    </a:r>
                  </a:p>
                </p:txBody>
              </p:sp>
            </mc:Choice>
            <mc:Fallback xmlns=""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1CAB69A0-8C9E-6272-A8BD-16F59003C143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0314150" y="4110341"/>
                    <a:ext cx="760565" cy="276999"/>
                  </a:xfrm>
                  <a:prstGeom prst="rect">
                    <a:avLst/>
                  </a:prstGeom>
                  <a:blipFill>
                    <a:blip r:embed="rId5"/>
                    <a:stretch>
                      <a:fillRect t="-2222" b="-17778"/>
                    </a:stretch>
                  </a:blipFill>
                </p:spPr>
                <p:txBody>
                  <a:bodyPr/>
                  <a:lstStyle/>
                  <a:p>
                    <a:r>
                      <a:rPr lang="en-IN">
                        <a:noFill/>
                      </a:rPr>
                      <a:t> </a:t>
                    </a:r>
                  </a:p>
                </p:txBody>
              </p:sp>
            </mc:Fallback>
          </mc:AlternateContent>
        </p:grp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F0A0383-07FE-7B22-1D7E-A91F19AC3FB6}"/>
                </a:ext>
              </a:extLst>
            </p:cNvPr>
            <p:cNvSpPr txBox="1"/>
            <p:nvPr/>
          </p:nvSpPr>
          <p:spPr>
            <a:xfrm>
              <a:off x="62715" y="70380"/>
              <a:ext cx="56899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194A6DF-E57A-2661-E923-23A2AAFFB6DF}"/>
                </a:ext>
              </a:extLst>
            </p:cNvPr>
            <p:cNvSpPr txBox="1"/>
            <p:nvPr/>
          </p:nvSpPr>
          <p:spPr>
            <a:xfrm>
              <a:off x="5576439" y="145794"/>
              <a:ext cx="56899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E830D1E-44D0-5852-DFD1-81029F3BA4D1}"/>
                </a:ext>
              </a:extLst>
            </p:cNvPr>
            <p:cNvSpPr txBox="1"/>
            <p:nvPr/>
          </p:nvSpPr>
          <p:spPr>
            <a:xfrm>
              <a:off x="62715" y="2996226"/>
              <a:ext cx="56899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B0A3B0CB-4102-CF1D-A95E-4F3C00C8C69F}"/>
              </a:ext>
            </a:extLst>
          </p:cNvPr>
          <p:cNvSpPr txBox="1"/>
          <p:nvPr/>
        </p:nvSpPr>
        <p:spPr>
          <a:xfrm>
            <a:off x="-18743" y="5913511"/>
            <a:ext cx="1210746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074738" indent="-1074738" algn="just"/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econdary structure evolution during MD simulation. (A) Unbound SERT, (B) SERT-Paroxetine complex, (C) SERT-Flunarizine complex. Each structure illustrates changes in secondary structure elements over the 500 ns trajectory, highlighting residual flexibility and conformational adaptations upon ligand binding.</a:t>
            </a:r>
            <a:endParaRPr lang="en-IN" sz="1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8447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0</TotalTime>
  <Words>146</Words>
  <Application>Microsoft Office PowerPoint</Application>
  <PresentationFormat>Widescreen</PresentationFormat>
  <Paragraphs>2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Aptos</vt:lpstr>
      <vt:lpstr>Aptos Display</vt:lpstr>
      <vt:lpstr>Arial</vt:lpstr>
      <vt:lpstr>Cambria Math</vt:lpstr>
      <vt:lpstr>Helvetica Neue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82</cp:revision>
  <dcterms:created xsi:type="dcterms:W3CDTF">2024-06-04T11:28:20Z</dcterms:created>
  <dcterms:modified xsi:type="dcterms:W3CDTF">2025-04-22T07:38:12Z</dcterms:modified>
</cp:coreProperties>
</file>